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44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467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1020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217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581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7234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621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9549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2791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993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613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058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CDDDF9-0884-4269-9674-E63586E0574B}" type="datetimeFigureOut">
              <a:rPr kumimoji="1" lang="ja-JP" altLang="en-US" smtClean="0"/>
              <a:t>2014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C665B-2656-45E2-95D8-E93E80DCC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4302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3377284"/>
              </p:ext>
            </p:extLst>
          </p:nvPr>
        </p:nvGraphicFramePr>
        <p:xfrm>
          <a:off x="230660" y="1889212"/>
          <a:ext cx="8690918" cy="30370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09469"/>
                <a:gridCol w="1602809"/>
                <a:gridCol w="685403"/>
                <a:gridCol w="685404"/>
                <a:gridCol w="5407833"/>
              </a:tblGrid>
              <a:tr h="205735">
                <a:tc>
                  <a:txBody>
                    <a:bodyPr/>
                    <a:lstStyle/>
                    <a:p>
                      <a:pPr algn="ctr" fontAlgn="b"/>
                      <a:endParaRPr lang="ja-JP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114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RANK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bles used</a:t>
                      </a:r>
                      <a:b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</a:b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in the model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UC of ROC</a:t>
                      </a:r>
                      <a:b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</a:b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No validation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UC of ROC</a:t>
                      </a:r>
                      <a:b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</a:b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LOOCV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FORMULA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HyPro,Glu,3MeHis,Tyr,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24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84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-0.1452)+(-0.2230)ｘEtOHNH2+(-0.04637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1303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Gl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524)ｘ3MeHis+(0.01250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yr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-0.03093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HyPro,Glu,3MeHis,Trp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14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80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0.05087)+(-0.1723)ｘEtOHNH2+(-0.04263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1487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Gl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359)ｘ3MeHis+(-0.02470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3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Sar,HyPro,3MeHis,Tyr,Trp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19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9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0.1183)+(-0.2385)ｘEtOHNH2+(-0.1620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Sar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-0.04135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4021)ｘ3MeHis+(0.01517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yr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-0.02703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4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Sar,HyPro,Glu,3MeHis,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18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9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0.1250)+(-0.1677)ｘEtOHNH2+(-0.1291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Sar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-0.03767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1453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Gl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556)ｘ3MeHis+(-0.02368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HyPro,Leu,Glu,3MeHis,Trp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18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9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0.1799)+(-0.1625)ｘEtOHNH2+(-0.04082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-0.003652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Le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1646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Gl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452)ｘ3MeHis+(-0.02123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6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HyPro,Leu,Glu,3MeHis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14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8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-0.2779)+(-0.1864)ｘEtOHNH2+(-0.04244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-0.008625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Le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1499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Gl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938)ｘ3MeHi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7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HyPro,Lys,Glu,3MeHis,Trp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16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8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-0.1599)+(-0.1805)ｘEtOHNH2+(-0.04420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02052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Lys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1443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Gl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303)ｘ3MeHis+(-0.02628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8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HyPro,Asp,3MeHis,Tyr,Trp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21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7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-0.1534)+(-0.2277)ｘEtOHNH2+(-0.04921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8864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Asp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745)ｘ3MeHis+(0.01444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yr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-0.02889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</a:t>
                      </a:r>
                      <a:endParaRPr lang="en-US" altLang="ja-JP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HyPro,Glu,3MeHis,Arg,Trp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20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6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-0.2486)+(-0.1750)ｘEtOHNH2+(-0.04510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1573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Gl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272)ｘ3MeHis+(0.003681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Arg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-0.02536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57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0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EtOHNH2,</a:t>
                      </a:r>
                      <a:r>
                        <a:rPr lang="el-GR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β-</a:t>
                      </a:r>
                      <a:r>
                        <a:rPr lang="en-US" sz="80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IBA,HyPro,Glu,3MeHis,Trp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15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6 </a:t>
                      </a:r>
                      <a:endParaRPr lang="en-US" altLang="ja-JP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0.08615)+(-0.1756)ｘEtOHNH2+(-0.01249)ｘ</a:t>
                      </a:r>
                      <a:r>
                        <a:rPr lang="el-GR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β-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IBA+(-0.04249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HyPro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01468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Glu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+(0.3426)ｘ3MeHis+(-0.02475)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ｘTrp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202" marR="7202" marT="720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160638" y="1524170"/>
            <a:ext cx="76817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0" i="0" dirty="0" smtClean="0">
                <a:effectLst/>
                <a:latin typeface="Times New Roman" panose="02020603050405020304" pitchFamily="18" charset="0"/>
              </a:rPr>
              <a:t>Table</a:t>
            </a:r>
            <a:r>
              <a:rPr lang="ja-JP" altLang="en-US" sz="1200" b="0" i="0" dirty="0" smtClean="0">
                <a:effectLst/>
                <a:latin typeface="Times New Roman" panose="02020603050405020304" pitchFamily="18" charset="0"/>
              </a:rPr>
              <a:t> </a:t>
            </a:r>
            <a:r>
              <a:rPr lang="en-US" altLang="ja-JP" sz="1200" b="0" i="0" dirty="0" smtClean="0">
                <a:effectLst/>
                <a:latin typeface="Times New Roman" panose="02020603050405020304" pitchFamily="18" charset="0"/>
              </a:rPr>
              <a:t>S</a:t>
            </a:r>
            <a:r>
              <a:rPr lang="en-US" altLang="ja-JP" sz="1200" dirty="0" smtClean="0">
                <a:latin typeface="Times New Roman" panose="02020603050405020304" pitchFamily="18" charset="0"/>
              </a:rPr>
              <a:t>1</a:t>
            </a:r>
            <a:r>
              <a:rPr lang="en-US" altLang="ja-JP" sz="1200" b="0" i="0" dirty="0" smtClean="0">
                <a:effectLst/>
                <a:latin typeface="Times New Roman" panose="02020603050405020304" pitchFamily="18" charset="0"/>
              </a:rPr>
              <a:t>. The top ten models performance using ROC of AUC.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400871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376</Words>
  <Application>Microsoft Office PowerPoint</Application>
  <PresentationFormat>画面に合わせる (4:3)</PresentationFormat>
  <Paragraphs>5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rial Unicode MS</vt:lpstr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ji</dc:creator>
  <cp:lastModifiedBy>Shinji</cp:lastModifiedBy>
  <cp:revision>10</cp:revision>
  <dcterms:created xsi:type="dcterms:W3CDTF">2014-04-07T00:43:16Z</dcterms:created>
  <dcterms:modified xsi:type="dcterms:W3CDTF">2014-06-08T00:29:44Z</dcterms:modified>
</cp:coreProperties>
</file>